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1436" userDrawn="1">
          <p15:clr>
            <a:srgbClr val="A4A3A4"/>
          </p15:clr>
        </p15:guide>
        <p15:guide id="4" orient="horz" pos="4407" userDrawn="1">
          <p15:clr>
            <a:srgbClr val="A4A3A4"/>
          </p15:clr>
        </p15:guide>
        <p15:guide id="5" orient="horz" pos="5677" userDrawn="1">
          <p15:clr>
            <a:srgbClr val="A4A3A4"/>
          </p15:clr>
        </p15:guide>
        <p15:guide id="6" pos="504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3568552-42BF-41B2-A50E-B7B6266727A2}" name="Mireille Vankemmelbeke" initials="MV" userId="S::MireilleVankemmelbeke@scancell.co.uk::e2496c92-8ae2-4817-81db-1e2fdf7923b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0" d="100"/>
          <a:sy n="50" d="100"/>
        </p:scale>
        <p:origin x="2690" y="34"/>
      </p:cViewPr>
      <p:guideLst>
        <p:guide orient="horz" pos="3840"/>
        <p:guide pos="2160"/>
        <p:guide orient="horz" pos="1436"/>
        <p:guide orient="horz" pos="4407"/>
        <p:guide orient="horz" pos="5677"/>
        <p:guide pos="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reille Vankemmelbeke" userId="e2496c92-8ae2-4817-81db-1e2fdf7923b3" providerId="ADAL" clId="{D48FDEE2-2644-4D7B-BD1A-1D767BB35B83}"/>
    <pc:docChg chg="custSel delSld modSld">
      <pc:chgData name="Mireille Vankemmelbeke" userId="e2496c92-8ae2-4817-81db-1e2fdf7923b3" providerId="ADAL" clId="{D48FDEE2-2644-4D7B-BD1A-1D767BB35B83}" dt="2024-06-21T15:47:11.030" v="3" actId="1076"/>
      <pc:docMkLst>
        <pc:docMk/>
      </pc:docMkLst>
      <pc:sldChg chg="del">
        <pc:chgData name="Mireille Vankemmelbeke" userId="e2496c92-8ae2-4817-81db-1e2fdf7923b3" providerId="ADAL" clId="{D48FDEE2-2644-4D7B-BD1A-1D767BB35B83}" dt="2024-06-21T15:46:58.273" v="0" actId="47"/>
        <pc:sldMkLst>
          <pc:docMk/>
          <pc:sldMk cId="3935331238" sldId="268"/>
        </pc:sldMkLst>
      </pc:sldChg>
      <pc:sldChg chg="delSp modSp mod">
        <pc:chgData name="Mireille Vankemmelbeke" userId="e2496c92-8ae2-4817-81db-1e2fdf7923b3" providerId="ADAL" clId="{D48FDEE2-2644-4D7B-BD1A-1D767BB35B83}" dt="2024-06-21T15:47:11.030" v="3" actId="1076"/>
        <pc:sldMkLst>
          <pc:docMk/>
          <pc:sldMk cId="868960993" sldId="269"/>
        </pc:sldMkLst>
        <pc:spChg chg="del">
          <ac:chgData name="Mireille Vankemmelbeke" userId="e2496c92-8ae2-4817-81db-1e2fdf7923b3" providerId="ADAL" clId="{D48FDEE2-2644-4D7B-BD1A-1D767BB35B83}" dt="2024-06-21T15:47:06.687" v="2" actId="478"/>
          <ac:spMkLst>
            <pc:docMk/>
            <pc:sldMk cId="868960993" sldId="269"/>
            <ac:spMk id="4" creationId="{5E3CACEE-8BE5-F31F-E9D6-FEF2DBE2523D}"/>
          </ac:spMkLst>
        </pc:spChg>
        <pc:spChg chg="del">
          <ac:chgData name="Mireille Vankemmelbeke" userId="e2496c92-8ae2-4817-81db-1e2fdf7923b3" providerId="ADAL" clId="{D48FDEE2-2644-4D7B-BD1A-1D767BB35B83}" dt="2024-06-21T15:47:06.687" v="2" actId="478"/>
          <ac:spMkLst>
            <pc:docMk/>
            <pc:sldMk cId="868960993" sldId="269"/>
            <ac:spMk id="7" creationId="{83275967-3BAD-8453-FBF6-8E47B83E5243}"/>
          </ac:spMkLst>
        </pc:spChg>
        <pc:spChg chg="del">
          <ac:chgData name="Mireille Vankemmelbeke" userId="e2496c92-8ae2-4817-81db-1e2fdf7923b3" providerId="ADAL" clId="{D48FDEE2-2644-4D7B-BD1A-1D767BB35B83}" dt="2024-06-21T15:47:06.687" v="2" actId="478"/>
          <ac:spMkLst>
            <pc:docMk/>
            <pc:sldMk cId="868960993" sldId="269"/>
            <ac:spMk id="9" creationId="{A86364A3-3171-51B5-56DC-97814CC6E14F}"/>
          </ac:spMkLst>
        </pc:spChg>
        <pc:spChg chg="mod">
          <ac:chgData name="Mireille Vankemmelbeke" userId="e2496c92-8ae2-4817-81db-1e2fdf7923b3" providerId="ADAL" clId="{D48FDEE2-2644-4D7B-BD1A-1D767BB35B83}" dt="2024-06-21T15:47:11.030" v="3" actId="1076"/>
          <ac:spMkLst>
            <pc:docMk/>
            <pc:sldMk cId="868960993" sldId="269"/>
            <ac:spMk id="10" creationId="{A6EE4B9E-931A-D0B8-45E9-DDDDD02F55DB}"/>
          </ac:spMkLst>
        </pc:spChg>
        <pc:spChg chg="del">
          <ac:chgData name="Mireille Vankemmelbeke" userId="e2496c92-8ae2-4817-81db-1e2fdf7923b3" providerId="ADAL" clId="{D48FDEE2-2644-4D7B-BD1A-1D767BB35B83}" dt="2024-06-21T15:47:06.687" v="2" actId="478"/>
          <ac:spMkLst>
            <pc:docMk/>
            <pc:sldMk cId="868960993" sldId="269"/>
            <ac:spMk id="14" creationId="{C0AD6B4A-FDED-1CF3-8BBF-3C89DC9125F8}"/>
          </ac:spMkLst>
        </pc:spChg>
        <pc:spChg chg="del">
          <ac:chgData name="Mireille Vankemmelbeke" userId="e2496c92-8ae2-4817-81db-1e2fdf7923b3" providerId="ADAL" clId="{D48FDEE2-2644-4D7B-BD1A-1D767BB35B83}" dt="2024-06-21T15:47:06.687" v="2" actId="478"/>
          <ac:spMkLst>
            <pc:docMk/>
            <pc:sldMk cId="868960993" sldId="269"/>
            <ac:spMk id="15" creationId="{AAA63D9A-720A-38FA-30FE-B64A03B0D307}"/>
          </ac:spMkLst>
        </pc:spChg>
        <pc:picChg chg="del">
          <ac:chgData name="Mireille Vankemmelbeke" userId="e2496c92-8ae2-4817-81db-1e2fdf7923b3" providerId="ADAL" clId="{D48FDEE2-2644-4D7B-BD1A-1D767BB35B83}" dt="2024-06-21T15:47:06.687" v="2" actId="478"/>
          <ac:picMkLst>
            <pc:docMk/>
            <pc:sldMk cId="868960993" sldId="269"/>
            <ac:picMk id="3" creationId="{07C6B656-125D-EBDD-6A94-0B7A000C716B}"/>
          </ac:picMkLst>
        </pc:picChg>
        <pc:picChg chg="del">
          <ac:chgData name="Mireille Vankemmelbeke" userId="e2496c92-8ae2-4817-81db-1e2fdf7923b3" providerId="ADAL" clId="{D48FDEE2-2644-4D7B-BD1A-1D767BB35B83}" dt="2024-06-21T15:47:06.687" v="2" actId="478"/>
          <ac:picMkLst>
            <pc:docMk/>
            <pc:sldMk cId="868960993" sldId="269"/>
            <ac:picMk id="11" creationId="{1B83C6A4-C081-437D-17C4-D1FA03343D30}"/>
          </ac:picMkLst>
        </pc:picChg>
        <pc:picChg chg="mod">
          <ac:chgData name="Mireille Vankemmelbeke" userId="e2496c92-8ae2-4817-81db-1e2fdf7923b3" providerId="ADAL" clId="{D48FDEE2-2644-4D7B-BD1A-1D767BB35B83}" dt="2024-06-21T15:47:11.030" v="3" actId="1076"/>
          <ac:picMkLst>
            <pc:docMk/>
            <pc:sldMk cId="868960993" sldId="269"/>
            <ac:picMk id="16" creationId="{436ACC07-BBAC-908B-678D-4EE4BA15215E}"/>
          </ac:picMkLst>
        </pc:picChg>
        <pc:picChg chg="del">
          <ac:chgData name="Mireille Vankemmelbeke" userId="e2496c92-8ae2-4817-81db-1e2fdf7923b3" providerId="ADAL" clId="{D48FDEE2-2644-4D7B-BD1A-1D767BB35B83}" dt="2024-06-21T15:47:06.687" v="2" actId="478"/>
          <ac:picMkLst>
            <pc:docMk/>
            <pc:sldMk cId="868960993" sldId="269"/>
            <ac:picMk id="17" creationId="{BD10C5BA-FE39-7C16-D7AC-4A4000C9580F}"/>
          </ac:picMkLst>
        </pc:picChg>
        <pc:picChg chg="del">
          <ac:chgData name="Mireille Vankemmelbeke" userId="e2496c92-8ae2-4817-81db-1e2fdf7923b3" providerId="ADAL" clId="{D48FDEE2-2644-4D7B-BD1A-1D767BB35B83}" dt="2024-06-21T15:47:06.687" v="2" actId="478"/>
          <ac:picMkLst>
            <pc:docMk/>
            <pc:sldMk cId="868960993" sldId="269"/>
            <ac:picMk id="19" creationId="{56993332-3CBE-EF21-6E05-DD9C043541F3}"/>
          </ac:picMkLst>
        </pc:picChg>
      </pc:sldChg>
      <pc:sldChg chg="del">
        <pc:chgData name="Mireille Vankemmelbeke" userId="e2496c92-8ae2-4817-81db-1e2fdf7923b3" providerId="ADAL" clId="{D48FDEE2-2644-4D7B-BD1A-1D767BB35B83}" dt="2024-06-21T15:47:01.512" v="1" actId="47"/>
        <pc:sldMkLst>
          <pc:docMk/>
          <pc:sldMk cId="2268793920" sldId="27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7ED1A2-C795-4A89-BC5A-004D576CF3D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34F97C-AF6A-4678-A188-E64139135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3147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4081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3431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703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1908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6323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9854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8744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9599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7021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3687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8485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5638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1">
            <a:extLst>
              <a:ext uri="{FF2B5EF4-FFF2-40B4-BE49-F238E27FC236}">
                <a16:creationId xmlns:a16="http://schemas.microsoft.com/office/drawing/2014/main" id="{A6EE4B9E-931A-D0B8-45E9-DDDDD02F55DB}"/>
              </a:ext>
            </a:extLst>
          </p:cNvPr>
          <p:cNvSpPr txBox="1"/>
          <p:nvPr/>
        </p:nvSpPr>
        <p:spPr>
          <a:xfrm>
            <a:off x="0" y="2535803"/>
            <a:ext cx="6656138" cy="5078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900" b="1"/>
              <a:t>Supplemental Figure 8. </a:t>
            </a:r>
            <a:r>
              <a:rPr lang="en-GB" sz="900"/>
              <a:t>Tumour growth in the </a:t>
            </a:r>
            <a:r>
              <a:rPr lang="en-GB" sz="900" err="1"/>
              <a:t>huPBMC</a:t>
            </a:r>
            <a:r>
              <a:rPr lang="en-GB" sz="900"/>
              <a:t> admixed anti-tumour study. PBMCs and DMS79 cells were both implanted on day 1 at E:T ratio 1:1. Two further PBMC doses were given on day 8 and 15 as indicated by the dotted lines. SC134-TCB (100 </a:t>
            </a:r>
            <a:r>
              <a:rPr lang="en-GB" sz="900">
                <a:latin typeface="Symbol" panose="05050102010706020507" pitchFamily="18" charset="2"/>
                <a:sym typeface="Symbol" panose="05050102010706020507" pitchFamily="18" charset="2"/>
              </a:rPr>
              <a:t></a:t>
            </a:r>
            <a:r>
              <a:rPr lang="en-GB" sz="900"/>
              <a:t>g) was given three times a week, for three weeks on days indicated by the arrows.</a:t>
            </a:r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6625F3AB-E145-5FC1-46A0-49170BFF6139}"/>
              </a:ext>
            </a:extLst>
          </p:cNvPr>
          <p:cNvSpPr txBox="1">
            <a:spLocks/>
          </p:cNvSpPr>
          <p:nvPr/>
        </p:nvSpPr>
        <p:spPr>
          <a:xfrm>
            <a:off x="30481" y="1107112"/>
            <a:ext cx="5604510" cy="10645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400" dirty="0"/>
              <a:t>Supplemental Figures</a:t>
            </a:r>
            <a:endParaRPr lang="en-GB" sz="1100" dirty="0"/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436ACC07-BBAC-908B-678D-4EE4BA15215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" t="14054" r="-1721"/>
          <a:stretch/>
        </p:blipFill>
        <p:spPr>
          <a:xfrm>
            <a:off x="480095" y="3112836"/>
            <a:ext cx="3543299" cy="15470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8960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3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eille Vankemmelbeke</dc:creator>
  <cp:lastModifiedBy>Mireille Vankemmelbeke</cp:lastModifiedBy>
  <cp:revision>3</cp:revision>
  <dcterms:created xsi:type="dcterms:W3CDTF">2024-03-08T14:10:38Z</dcterms:created>
  <dcterms:modified xsi:type="dcterms:W3CDTF">2024-06-21T15:47:12Z</dcterms:modified>
</cp:coreProperties>
</file>